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64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99292-6057-4389-9709-1081273079D2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AF22C-0815-4BFF-BC16-67763DAD2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169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99292-6057-4389-9709-1081273079D2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AF22C-0815-4BFF-BC16-67763DAD2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636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99292-6057-4389-9709-1081273079D2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AF22C-0815-4BFF-BC16-67763DAD2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878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99292-6057-4389-9709-1081273079D2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AF22C-0815-4BFF-BC16-67763DAD2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844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99292-6057-4389-9709-1081273079D2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AF22C-0815-4BFF-BC16-67763DAD2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702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99292-6057-4389-9709-1081273079D2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AF22C-0815-4BFF-BC16-67763DAD2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059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99292-6057-4389-9709-1081273079D2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AF22C-0815-4BFF-BC16-67763DAD2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159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99292-6057-4389-9709-1081273079D2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AF22C-0815-4BFF-BC16-67763DAD2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068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99292-6057-4389-9709-1081273079D2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AF22C-0815-4BFF-BC16-67763DAD2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957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99292-6057-4389-9709-1081273079D2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AF22C-0815-4BFF-BC16-67763DAD2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153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99292-6057-4389-9709-1081273079D2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AF22C-0815-4BFF-BC16-67763DAD2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159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99292-6057-4389-9709-1081273079D2}" type="datetimeFigureOut">
              <a:rPr lang="en-US" smtClean="0"/>
              <a:t>5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2AF22C-0815-4BFF-BC16-67763DAD2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052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ChangeArrowheads="1"/>
          </p:cNvSpPr>
          <p:nvPr/>
        </p:nvSpPr>
        <p:spPr bwMode="auto">
          <a:xfrm>
            <a:off x="342900" y="4973638"/>
            <a:ext cx="8458200" cy="1200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just"/>
            <a:r>
              <a:rPr lang="en-US" b="1">
                <a:latin typeface="Arial" pitchFamily="34" charset="0"/>
                <a:cs typeface="Arial" pitchFamily="34" charset="0"/>
              </a:rPr>
              <a:t>Supplementary Figure S2</a:t>
            </a:r>
            <a:r>
              <a:rPr lang="en-US">
                <a:latin typeface="Arial" pitchFamily="34" charset="0"/>
                <a:cs typeface="Arial" pitchFamily="34" charset="0"/>
              </a:rPr>
              <a:t>: </a:t>
            </a:r>
            <a:r>
              <a:rPr lang="en-US" b="1">
                <a:latin typeface="Arial" pitchFamily="34" charset="0"/>
                <a:cs typeface="Arial" pitchFamily="34" charset="0"/>
              </a:rPr>
              <a:t>Enriched triplets for C-to-A edited miRNAs. </a:t>
            </a:r>
          </a:p>
          <a:p>
            <a:pPr algn="just"/>
            <a:r>
              <a:rPr lang="en-US">
                <a:latin typeface="Arial" pitchFamily="34" charset="0"/>
                <a:cs typeface="Arial" pitchFamily="34" charset="0"/>
              </a:rPr>
              <a:t>Y-axis represents the tri-nucleotide proportion in C-to-A edited miRNAs (in pink) compared to that in all pre-miRNAs (in green). </a:t>
            </a:r>
            <a:r>
              <a:rPr lang="en-IN">
                <a:latin typeface="Arial" pitchFamily="34" charset="0"/>
                <a:cs typeface="Arial" pitchFamily="34" charset="0"/>
              </a:rPr>
              <a:t>“UCA”, “ACC“ and “CCA” are the top three enriched triplets present in miRNAs harboring C-to-A editing.</a:t>
            </a:r>
            <a:endParaRPr lang="en-US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075" name="Group 1"/>
          <p:cNvGrpSpPr>
            <a:grpSpLocks/>
          </p:cNvGrpSpPr>
          <p:nvPr/>
        </p:nvGrpSpPr>
        <p:grpSpPr bwMode="auto">
          <a:xfrm>
            <a:off x="458788" y="673100"/>
            <a:ext cx="8185150" cy="4057650"/>
            <a:chOff x="306388" y="673100"/>
            <a:chExt cx="8185150" cy="4057650"/>
          </a:xfrm>
        </p:grpSpPr>
        <p:pic>
          <p:nvPicPr>
            <p:cNvPr id="3076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94"/>
            <a:stretch>
              <a:fillRect/>
            </a:stretch>
          </p:blipFill>
          <p:spPr bwMode="auto">
            <a:xfrm>
              <a:off x="693738" y="673100"/>
              <a:ext cx="7797800" cy="4057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77" name="TextBox 1"/>
            <p:cNvSpPr txBox="1">
              <a:spLocks noChangeArrowheads="1"/>
            </p:cNvSpPr>
            <p:nvPr/>
          </p:nvSpPr>
          <p:spPr bwMode="auto">
            <a:xfrm rot="-5400000">
              <a:off x="-604043" y="2389981"/>
              <a:ext cx="2190750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/>
              <a:r>
                <a:rPr lang="en-US" b="1">
                  <a:latin typeface="Arial" pitchFamily="34" charset="0"/>
                  <a:cs typeface="Arial" pitchFamily="34" charset="0"/>
                </a:rPr>
                <a:t>Triplet proport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15819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9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panjan</dc:creator>
  <cp:lastModifiedBy>Deepanjan</cp:lastModifiedBy>
  <cp:revision>1</cp:revision>
  <dcterms:created xsi:type="dcterms:W3CDTF">2020-05-23T20:22:37Z</dcterms:created>
  <dcterms:modified xsi:type="dcterms:W3CDTF">2020-05-23T20:23:55Z</dcterms:modified>
</cp:coreProperties>
</file>